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9" r:id="rId3"/>
    <p:sldId id="260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 userDrawn="1">
          <p15:clr>
            <a:srgbClr val="A4A3A4"/>
          </p15:clr>
        </p15:guide>
        <p15:guide id="2" pos="3221" userDrawn="1">
          <p15:clr>
            <a:srgbClr val="A4A3A4"/>
          </p15:clr>
        </p15:guide>
        <p15:guide id="3" pos="12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>
        <p:scale>
          <a:sx n="60" d="100"/>
          <a:sy n="60" d="100"/>
        </p:scale>
        <p:origin x="1800" y="822"/>
      </p:cViewPr>
      <p:guideLst>
        <p:guide orient="horz" pos="2903"/>
        <p:guide pos="3221"/>
        <p:guide pos="12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9877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276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366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29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7679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1337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381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04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842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381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0655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729B4-A6BC-4A31-B21E-AB0FE2DCF041}" type="datetimeFigureOut">
              <a:rPr lang="en-GB" smtClean="0"/>
              <a:t>1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2D328-EA93-459D-AF84-CE9D709747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32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467107" y="7297872"/>
            <a:ext cx="624131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S2A Fig</a:t>
            </a:r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Trait variation measured in flowing solution culture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with optimum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N and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, low N and optimum P and optimum N and low P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across the parental genotypes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F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M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M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L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L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Con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family mean (C), S1-S7 (1-7) and S1fam-S7fam. For Sfam1-Sfam7 each column in the graph is the mean of the trait scores for the genotypes within that family containing an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introgression at that particular position (illustrated below the </a:t>
            </a:r>
            <a:r>
              <a:rPr lang="en-US" sz="1200" i="1" dirty="0">
                <a:ea typeface="Calibri" panose="020F0502020204030204" pitchFamily="34" charset="0"/>
                <a:cs typeface="Times New Roman" panose="02020603050405020304" pitchFamily="18" charset="0"/>
              </a:rPr>
              <a:t>x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axis). For each illustration of the pattern of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introgression in S1fam-S7fam, each row represents a single genotype and each column a defined and sequential region of the chromosome from end to end. A red square indicates an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introgression at that relative position in that particular genotype; a green square indicates the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background. Error bars are standard errors (n&lt;2) or the range (n=2). 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62368" y="0"/>
            <a:ext cx="6870787" cy="7309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04666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91485" y="7432746"/>
            <a:ext cx="616651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S2B Fig.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Tiller number after 2 week recovery period </a:t>
            </a:r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following partial flooding at 10</a:t>
            </a:r>
            <a:r>
              <a:rPr lang="en-US" sz="1200" b="1" baseline="300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C and 20</a:t>
            </a:r>
            <a:r>
              <a:rPr lang="en-US" sz="1200" b="1" baseline="300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C for 3 or 6 weeks across 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the parental genotypes </a:t>
            </a:r>
            <a:r>
              <a:rPr lang="en-US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(F), </a:t>
            </a:r>
            <a:r>
              <a:rPr lang="en-US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LpM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(M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L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L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Con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family mean (C), S1-S7 (1-7) and S1fam-S7fam.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For the no flooding control, tiller number was measured 2 weeks after plants were cut back.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847"/>
          <a:stretch/>
        </p:blipFill>
        <p:spPr>
          <a:xfrm>
            <a:off x="465220" y="354677"/>
            <a:ext cx="6392779" cy="7078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2548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5361"/>
            <a:ext cx="6633638" cy="661932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91485" y="7071164"/>
            <a:ext cx="61665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S2C Fig.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Trait variation following drought treatments and glasshouse evaluations across the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parental genotypes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Fp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F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M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M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L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(L), </a:t>
            </a:r>
            <a:r>
              <a:rPr lang="en-US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LpCon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family mean (C), S1-S7 (1-7) and S1fam-S7fam. 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818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17</TotalTime>
  <Words>272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Ian Armstead [ipa]</cp:lastModifiedBy>
  <cp:revision>11</cp:revision>
  <dcterms:created xsi:type="dcterms:W3CDTF">2018-05-23T08:46:56Z</dcterms:created>
  <dcterms:modified xsi:type="dcterms:W3CDTF">2018-08-16T11:18:17Z</dcterms:modified>
</cp:coreProperties>
</file>